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929B5C-4EF6-42E7-9D6A-DF2DA62D905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9858BA-8F89-421A-85EF-805199DDE0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863BEA-0031-481E-9056-03117C50A30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413FC4-5A96-4F1C-A8BF-D22ACEB5A37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FB87BF-E5D9-4772-B28B-0AD03F42C0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30A27B-D8C0-4871-9AF1-0C846D761B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726165-C7C4-4FB7-B6D1-B4054C53F89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A62021-162C-4AF5-A877-C1B9508FA8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ED08D9-3A7D-4CA7-B114-6E0C2C581F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ED140A-12AA-43B2-B622-86C7B40D25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A7A334-75AD-4056-8FC6-B083D1D669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53E08A-5A29-4257-B718-427A283C19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4C9285-4B79-4BCD-9053-1BC24ACD61DE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400800" y="457200"/>
            <a:ext cx="76320" cy="380880"/>
          </a:xfrm>
          <a:prstGeom prst="upArrow">
            <a:avLst>
              <a:gd name="adj1" fmla="val 50000"/>
              <a:gd name="adj2" fmla="val 124764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2743200" y="8077320"/>
            <a:ext cx="205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Times New Roman"/>
              </a:rPr>
              <a:t>Supplementary Figure 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3" name=""/>
          <p:cNvGrpSpPr/>
          <p:nvPr/>
        </p:nvGrpSpPr>
        <p:grpSpPr>
          <a:xfrm>
            <a:off x="1863720" y="3489480"/>
            <a:ext cx="3165480" cy="2148480"/>
            <a:chOff x="1863720" y="3489480"/>
            <a:chExt cx="3165480" cy="2148480"/>
          </a:xfrm>
        </p:grpSpPr>
        <p:sp>
          <p:nvSpPr>
            <p:cNvPr id="44" name=""/>
            <p:cNvSpPr/>
            <p:nvPr/>
          </p:nvSpPr>
          <p:spPr>
            <a:xfrm>
              <a:off x="4370400" y="4745160"/>
              <a:ext cx="436680" cy="1440"/>
            </a:xfrm>
            <a:prstGeom prst="line">
              <a:avLst/>
            </a:prstGeom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4573440" y="5030640"/>
              <a:ext cx="30240" cy="28800"/>
            </a:xfrm>
            <a:custGeom>
              <a:avLst/>
              <a:gdLst/>
              <a:ahLst/>
              <a:rect l="l" t="t" r="r" b="b"/>
              <a:pathLst>
                <a:path w="61" h="61">
                  <a:moveTo>
                    <a:pt x="31" y="0"/>
                  </a:moveTo>
                  <a:lnTo>
                    <a:pt x="61" y="61"/>
                  </a:lnTo>
                  <a:lnTo>
                    <a:pt x="0" y="61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ff0000"/>
            </a:solidFill>
            <a:ln w="144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16920" bIns="-16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4573440" y="4916520"/>
              <a:ext cx="30240" cy="27000"/>
            </a:xfrm>
            <a:custGeom>
              <a:avLst/>
              <a:gdLst/>
              <a:ahLst/>
              <a:rect l="l" t="t" r="r" b="b"/>
              <a:pathLst>
                <a:path w="61" h="62">
                  <a:moveTo>
                    <a:pt x="31" y="0"/>
                  </a:moveTo>
                  <a:lnTo>
                    <a:pt x="61" y="62"/>
                  </a:lnTo>
                  <a:lnTo>
                    <a:pt x="0" y="62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ff0000"/>
            </a:solidFill>
            <a:ln w="144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18720" bIns="-18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573440" y="4579920"/>
              <a:ext cx="30240" cy="28440"/>
            </a:xfrm>
            <a:custGeom>
              <a:avLst/>
              <a:gdLst/>
              <a:ahLst/>
              <a:rect l="l" t="t" r="r" b="b"/>
              <a:pathLst>
                <a:path w="61" h="62">
                  <a:moveTo>
                    <a:pt x="31" y="0"/>
                  </a:moveTo>
                  <a:lnTo>
                    <a:pt x="61" y="62"/>
                  </a:lnTo>
                  <a:lnTo>
                    <a:pt x="0" y="62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ff0000"/>
            </a:solidFill>
            <a:ln w="144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17280" bIns="-17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573440" y="4398840"/>
              <a:ext cx="30240" cy="28800"/>
            </a:xfrm>
            <a:custGeom>
              <a:avLst/>
              <a:gdLst/>
              <a:ahLst/>
              <a:rect l="l" t="t" r="r" b="b"/>
              <a:pathLst>
                <a:path w="61" h="62">
                  <a:moveTo>
                    <a:pt x="31" y="0"/>
                  </a:moveTo>
                  <a:lnTo>
                    <a:pt x="61" y="62"/>
                  </a:lnTo>
                  <a:lnTo>
                    <a:pt x="0" y="62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ff0000"/>
            </a:solidFill>
            <a:ln w="144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16920" bIns="-16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714840" y="4417920"/>
              <a:ext cx="436320" cy="0"/>
            </a:xfrm>
            <a:prstGeom prst="line">
              <a:avLst/>
            </a:prstGeom>
            <a:ln w="9360">
              <a:solidFill>
                <a:srgbClr val="000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917880" y="4675320"/>
              <a:ext cx="30240" cy="29880"/>
            </a:xfrm>
            <a:prstGeom prst="ellipse">
              <a:avLst/>
            </a:prstGeom>
            <a:solidFill>
              <a:srgbClr val="0000c0"/>
            </a:solidFill>
            <a:ln w="1440">
              <a:solidFill>
                <a:srgbClr val="000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3917880" y="4552920"/>
              <a:ext cx="30240" cy="30240"/>
            </a:xfrm>
            <a:prstGeom prst="ellipse">
              <a:avLst/>
            </a:prstGeom>
            <a:solidFill>
              <a:srgbClr val="0000c0"/>
            </a:solidFill>
            <a:ln w="1440">
              <a:solidFill>
                <a:srgbClr val="000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0" bIns="-25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917880" y="4398840"/>
              <a:ext cx="30240" cy="28800"/>
            </a:xfrm>
            <a:prstGeom prst="ellipse">
              <a:avLst/>
            </a:prstGeom>
            <a:solidFill>
              <a:srgbClr val="0000c0"/>
            </a:solidFill>
            <a:ln w="1440">
              <a:solidFill>
                <a:srgbClr val="000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3917880" y="3987720"/>
              <a:ext cx="30240" cy="28800"/>
            </a:xfrm>
            <a:prstGeom prst="ellipse">
              <a:avLst/>
            </a:prstGeom>
            <a:solidFill>
              <a:srgbClr val="0000c0"/>
            </a:solidFill>
            <a:ln w="1440">
              <a:solidFill>
                <a:srgbClr val="000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059280" y="4965840"/>
              <a:ext cx="436320" cy="1440"/>
            </a:xfrm>
            <a:prstGeom prst="line">
              <a:avLst/>
            </a:prstGeom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263760" y="5110200"/>
              <a:ext cx="27000" cy="28440"/>
            </a:xfrm>
            <a:custGeom>
              <a:avLst/>
              <a:gdLst/>
              <a:ahLst/>
              <a:rect l="l" t="t" r="r" b="b"/>
              <a:pathLst>
                <a:path w="62" h="62">
                  <a:moveTo>
                    <a:pt x="31" y="0"/>
                  </a:moveTo>
                  <a:lnTo>
                    <a:pt x="62" y="62"/>
                  </a:lnTo>
                  <a:lnTo>
                    <a:pt x="0" y="62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17280" bIns="-17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3306600" y="5076720"/>
              <a:ext cx="28800" cy="30240"/>
            </a:xfrm>
            <a:custGeom>
              <a:avLst/>
              <a:gdLst/>
              <a:ahLst/>
              <a:rect l="l" t="t" r="r" b="b"/>
              <a:pathLst>
                <a:path w="62" h="61">
                  <a:moveTo>
                    <a:pt x="31" y="0"/>
                  </a:moveTo>
                  <a:lnTo>
                    <a:pt x="62" y="61"/>
                  </a:lnTo>
                  <a:lnTo>
                    <a:pt x="0" y="61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15480" bIns="-15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263760" y="4954680"/>
              <a:ext cx="27000" cy="28440"/>
            </a:xfrm>
            <a:custGeom>
              <a:avLst/>
              <a:gdLst/>
              <a:ahLst/>
              <a:rect l="l" t="t" r="r" b="b"/>
              <a:pathLst>
                <a:path w="62" h="61">
                  <a:moveTo>
                    <a:pt x="31" y="0"/>
                  </a:moveTo>
                  <a:lnTo>
                    <a:pt x="62" y="61"/>
                  </a:lnTo>
                  <a:lnTo>
                    <a:pt x="0" y="61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17280" bIns="-17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263760" y="4664160"/>
              <a:ext cx="27000" cy="28440"/>
            </a:xfrm>
            <a:custGeom>
              <a:avLst/>
              <a:gdLst/>
              <a:ahLst/>
              <a:rect l="l" t="t" r="r" b="b"/>
              <a:pathLst>
                <a:path w="62" h="61">
                  <a:moveTo>
                    <a:pt x="31" y="0"/>
                  </a:moveTo>
                  <a:lnTo>
                    <a:pt x="62" y="61"/>
                  </a:lnTo>
                  <a:lnTo>
                    <a:pt x="0" y="61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17280" bIns="-17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403360" y="4694400"/>
              <a:ext cx="436680" cy="0"/>
            </a:xfrm>
            <a:prstGeom prst="line">
              <a:avLst/>
            </a:prstGeom>
            <a:ln w="9360">
              <a:solidFill>
                <a:srgbClr val="000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608200" y="5030640"/>
              <a:ext cx="28800" cy="288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608200" y="4816440"/>
              <a:ext cx="28800" cy="30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0" bIns="-25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608200" y="4468680"/>
              <a:ext cx="28800" cy="30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0" bIns="-25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608200" y="4398840"/>
              <a:ext cx="28800" cy="288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185920" y="5424480"/>
              <a:ext cx="2843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2360880" y="5454720"/>
              <a:ext cx="549360" cy="18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AT" sz="600" spc="-1" strike="noStrike">
                  <a:solidFill>
                    <a:srgbClr val="000000"/>
                  </a:solidFill>
                  <a:latin typeface="Arial"/>
                </a:rPr>
                <a:t>Normal Tissue 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AT" sz="600" spc="-1" strike="noStrike">
                  <a:solidFill>
                    <a:srgbClr val="000000"/>
                  </a:solidFill>
                  <a:latin typeface="Arial"/>
                </a:rPr>
                <a:t>CI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3032280" y="5454720"/>
              <a:ext cx="524880" cy="18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AT" sz="600" spc="-1" strike="noStrike">
                  <a:solidFill>
                    <a:srgbClr val="000000"/>
                  </a:solidFill>
                  <a:latin typeface="Arial"/>
                </a:rPr>
                <a:t>Tumor Tissue 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AT" sz="600" spc="-1" strike="noStrike">
                  <a:solidFill>
                    <a:srgbClr val="000000"/>
                  </a:solidFill>
                  <a:latin typeface="Arial"/>
                </a:rPr>
                <a:t>CI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3657600" y="5454720"/>
              <a:ext cx="549360" cy="18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AT" sz="600" spc="-1" strike="noStrike">
                  <a:solidFill>
                    <a:srgbClr val="000000"/>
                  </a:solidFill>
                  <a:latin typeface="Arial"/>
                </a:rPr>
                <a:t>Normal Tissue 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AT" sz="600" spc="-1" strike="noStrike">
                  <a:solidFill>
                    <a:srgbClr val="000000"/>
                  </a:solidFill>
                  <a:latin typeface="Arial"/>
                </a:rPr>
                <a:t>CV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4329360" y="5454720"/>
              <a:ext cx="524880" cy="18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AT" sz="600" spc="-1" strike="noStrike">
                  <a:solidFill>
                    <a:srgbClr val="000000"/>
                  </a:solidFill>
                  <a:latin typeface="Arial"/>
                </a:rPr>
                <a:t>Tumor Tissue 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AT" sz="600" spc="-1" strike="noStrike">
                  <a:solidFill>
                    <a:srgbClr val="000000"/>
                  </a:solidFill>
                  <a:latin typeface="Arial"/>
                </a:rPr>
                <a:t>CV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 flipV="1">
              <a:off x="2185920" y="3527280"/>
              <a:ext cx="0" cy="189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 flipH="1">
              <a:off x="2158560" y="5424480"/>
              <a:ext cx="27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080800" y="53848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 flipH="1">
              <a:off x="2158560" y="5108400"/>
              <a:ext cx="2700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2043000" y="507060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 flipH="1">
              <a:off x="2158560" y="4792680"/>
              <a:ext cx="27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2006640" y="475308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 flipH="1">
              <a:off x="2158560" y="4475160"/>
              <a:ext cx="270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006640" y="443880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15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 flipH="1">
              <a:off x="2158560" y="4160880"/>
              <a:ext cx="27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2006640" y="412272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 flipH="1">
              <a:off x="2158560" y="3843360"/>
              <a:ext cx="270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2006640" y="380520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25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 flipH="1">
              <a:off x="2158560" y="3527280"/>
              <a:ext cx="2700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2006640" y="348948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30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 rot="16200000">
              <a:off x="1710360" y="4385520"/>
              <a:ext cx="41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SCORING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2-18T10:18:40Z</dcterms:created>
  <dc:creator>Franz Zimmermann</dc:creator>
  <dc:description/>
  <dc:language>en-US</dc:language>
  <cp:lastModifiedBy>Zimmermann Franz</cp:lastModifiedBy>
  <dcterms:modified xsi:type="dcterms:W3CDTF">2009-03-11T10:07:21Z</dcterms:modified>
  <cp:revision>4</cp:revision>
  <dc:subject/>
  <dc:title>PowerPoint-Präsentation</dc:title>
</cp:coreProperties>
</file>